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0" r:id="rId1"/>
  </p:sldMasterIdLst>
  <p:sldIdLst>
    <p:sldId id="259" r:id="rId2"/>
  </p:sldIdLst>
  <p:sldSz cx="12192000" cy="6858000"/>
  <p:notesSz cx="6858000" cy="9144000"/>
  <p:defaultTextStyle>
    <a:defPPr>
      <a:defRPr lang="it-G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196"/>
  </p:normalViewPr>
  <p:slideViewPr>
    <p:cSldViewPr snapToGrid="0">
      <p:cViewPr varScale="1">
        <p:scale>
          <a:sx n="96" d="100"/>
          <a:sy n="96" d="100"/>
        </p:scale>
        <p:origin x="6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FAD2F87-00AE-F884-C070-FDC137129E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BF479B8-F2F2-C79C-2846-E2E0362558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A925893-5EFA-82AC-9EC5-FED88F8BE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A824-1A51-4B26-AD58-A6D8E14F6C04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99C9BD-8B51-C51A-38FB-105BD8A89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9B9B56E-EEEB-5AD2-8C13-4EC01E892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4483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6246BB-40B3-9695-6B51-7EC734EA7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9B7667F-3277-7CCF-EE30-C6931F4F79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89E8929-04B6-EFE1-1C99-C737720F0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7E33E-8B18-4087-B112-809917729534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61FF39-3090-E9C2-CF61-1DF8C8410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FD64320-2AB4-533C-3BF1-DB7B440F2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5895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2E062C7-854F-C83A-5F94-92104406AD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3F17A2B-7D2D-2A47-4C2D-C94B0C05F3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8D32A47-DD76-C2FE-2907-0C8447675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1BDCC4E-08E1-926E-C599-563459EAC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109C81-218C-8B4A-8DC6-FF6C1068B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0129487"/>
      </p:ext>
    </p:extLst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473B33-2AD1-C066-279D-2FF06BFF91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87A7420-B2F7-55DC-40DD-6ACCCA5D56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0C0D12-34FF-BA14-C2B5-7210DE235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162C4-EDD9-4389-A98B-B87ECEA2A816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253B21-F3A2-EEA8-EF3E-A472B2800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DAC0AAD-14D3-1292-FD2D-0F862B588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1148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CFE00E-A3D0-360B-67CE-43C0147B81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4B8B396-8963-A2D9-8617-B2A7C791B2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8F2AA82-1CB2-72E8-CBA3-AF13B52B5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059C3-6A89-4494-99FF-5A4D6FFD50EB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673E408-6468-AC6E-29F3-AB8D79EAB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714C3D-A503-B0C0-C46A-677859223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1397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8F0A6C-8D48-B5BC-C9C3-4FDF20159C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9FE5335-46EF-6E47-4013-3DEBBE90CD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0DCE59E-4108-2226-B4EE-2EF0F30DF2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DDEFB08-5EEA-E67F-F0E8-04592D601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4B2F-12DE-47F5-8894-472B206D2E1E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D5B1B0A-5BA0-BAD0-EE7C-9D0404648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126FFB5-EA02-09B7-519F-96BE4D49E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0042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CA5C25-8489-CEB7-647D-A1172B904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2E1E58E-E6B7-E5E4-F89F-14710D34B7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85CBE6B-003D-FCF9-5CEB-22B2E39EA8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9B81EF5-E385-9AD3-906B-4D430A1415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AD331DA-6F20-F166-52FF-0E606A7BDB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1EBF5B6-C0C7-EEB4-0B54-170D6DFD1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0E46F-7819-4ACF-B48B-48222C2ACC88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B102EB6-0C6E-7A01-270B-D2C313AB6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98E5B10-603E-F870-DC38-3018B1DDA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3441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21AD3BA-725F-4AF1-2A1B-2E2E360E6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41C1E0C-14E2-DB8A-4446-83B9A3141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F3416-4057-4DAA-829D-4CA07428D088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5694881-CD91-DC6F-4153-F29AD31D6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AE32671-7D77-343B-051E-A326C3D01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8930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7B5E769-FB76-D43C-8998-DCDE8BF7D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D9284-D300-4297-87F7-E791DCC15DB1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3FB4482-50E1-E6FE-D121-42BA9EE55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CE12613-B665-C4F9-10C7-5C61ADA88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7661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A079423-AEED-1227-E43A-47FABE8476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F96C9C2-E1BC-CCA1-807E-8EC2270D6A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49CECCD-4B99-0CFD-BCC0-910A8715E8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958CE93-47B2-153A-8938-4295864A7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25BB-DA17-4BA0-B3C8-3AC3ABC827E6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A33016C-6C80-6C7A-305E-7348949B5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89EE27A-4CD9-CD3E-CBF1-B065F944B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4555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9C61CB5-09FD-FDF2-CC24-4BF6B4A55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7AC4725-9206-CBA5-25F7-8AA783A67F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75CF454-D169-60A7-5A14-EEBE04E0C6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39611FD-41DD-1D30-9C32-A3B080B4A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C4C9A-3960-41CF-A4E9-2A8FB932454B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B10C34F-029D-AB40-741E-A8956F918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C27EE37-CD0B-E61A-51D3-2AE29ACF8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2477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07E5973-A93F-857E-BC32-4B4ABABECB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7EA0881-4A54-492F-7745-A18893C677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13872A-0D6B-A1D6-3E23-8583553BB7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C1C18-307B-4F68-A007-B5B542270E8D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05ED6C9-9019-1FB8-C6CA-9D493F85B7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829024F-AEBD-F8EF-1F27-C115C73C67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4737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G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F949A3FF-D9D4-4FD8-556D-AAAC86027AD9}"/>
              </a:ext>
            </a:extLst>
          </p:cNvPr>
          <p:cNvSpPr txBox="1"/>
          <p:nvPr/>
        </p:nvSpPr>
        <p:spPr>
          <a:xfrm>
            <a:off x="7148127" y="5286148"/>
            <a:ext cx="36641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1. Input FANCJ WT</a:t>
            </a:r>
          </a:p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2. Input FANCJ AALA</a:t>
            </a:r>
          </a:p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3. IP-anti-Myc (AND-1 with FANCJ WT)</a:t>
            </a:r>
          </a:p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4. IP-anti-Myc (AND-1 with FANCJ AALA)</a:t>
            </a:r>
          </a:p>
        </p:txBody>
      </p:sp>
      <p:grpSp>
        <p:nvGrpSpPr>
          <p:cNvPr id="34" name="Gruppo 33">
            <a:extLst>
              <a:ext uri="{FF2B5EF4-FFF2-40B4-BE49-F238E27FC236}">
                <a16:creationId xmlns:a16="http://schemas.microsoft.com/office/drawing/2014/main" id="{8862EB9A-B090-B60F-BBB4-F4CD26300B9F}"/>
              </a:ext>
            </a:extLst>
          </p:cNvPr>
          <p:cNvGrpSpPr/>
          <p:nvPr/>
        </p:nvGrpSpPr>
        <p:grpSpPr>
          <a:xfrm>
            <a:off x="5848085" y="1284111"/>
            <a:ext cx="5404755" cy="3657600"/>
            <a:chOff x="5848085" y="1284111"/>
            <a:chExt cx="5404755" cy="3657600"/>
          </a:xfrm>
        </p:grpSpPr>
        <p:pic>
          <p:nvPicPr>
            <p:cNvPr id="4" name="Immagine 3" descr="Immagine che contiene schizzo, bianco, nero, bianco e nero&#10;&#10;Descrizione generata automaticamente">
              <a:extLst>
                <a:ext uri="{FF2B5EF4-FFF2-40B4-BE49-F238E27FC236}">
                  <a16:creationId xmlns:a16="http://schemas.microsoft.com/office/drawing/2014/main" id="{B065D497-EFEB-C229-C95A-F8160A09E4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15000" contrast="32000"/>
                      </a14:imgEffect>
                    </a14:imgLayer>
                  </a14:imgProps>
                </a:ext>
              </a:extLst>
            </a:blip>
            <a:srcRect l="33283" t="17026" r="40649" b="28912"/>
            <a:stretch/>
          </p:blipFill>
          <p:spPr>
            <a:xfrm>
              <a:off x="7305589" y="1284111"/>
              <a:ext cx="2809701" cy="3657600"/>
            </a:xfrm>
            <a:prstGeom prst="rect">
              <a:avLst/>
            </a:prstGeom>
          </p:spPr>
        </p:pic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E3F831B3-D6DF-AC73-0E0E-0FF76B17439C}"/>
                </a:ext>
              </a:extLst>
            </p:cNvPr>
            <p:cNvSpPr txBox="1"/>
            <p:nvPr/>
          </p:nvSpPr>
          <p:spPr>
            <a:xfrm>
              <a:off x="5848085" y="2468614"/>
              <a:ext cx="158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200" b="1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Flag (FANCJ)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770236B5-B778-C4FB-1C57-26DB37E14A61}"/>
                </a:ext>
              </a:extLst>
            </p:cNvPr>
            <p:cNvSpPr txBox="1"/>
            <p:nvPr/>
          </p:nvSpPr>
          <p:spPr>
            <a:xfrm>
              <a:off x="7226077" y="1316808"/>
              <a:ext cx="2676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4         3          2       1</a:t>
              </a:r>
            </a:p>
          </p:txBody>
        </p:sp>
        <p:grpSp>
          <p:nvGrpSpPr>
            <p:cNvPr id="7" name="Gruppo 6">
              <a:extLst>
                <a:ext uri="{FF2B5EF4-FFF2-40B4-BE49-F238E27FC236}">
                  <a16:creationId xmlns:a16="http://schemas.microsoft.com/office/drawing/2014/main" id="{DB251CB7-3BD7-977E-32E3-926E51C3A464}"/>
                </a:ext>
              </a:extLst>
            </p:cNvPr>
            <p:cNvGrpSpPr/>
            <p:nvPr/>
          </p:nvGrpSpPr>
          <p:grpSpPr>
            <a:xfrm>
              <a:off x="10101439" y="1980526"/>
              <a:ext cx="1151401" cy="1574605"/>
              <a:chOff x="8891850" y="1644066"/>
              <a:chExt cx="1151401" cy="1574605"/>
            </a:xfrm>
          </p:grpSpPr>
          <p:cxnSp>
            <p:nvCxnSpPr>
              <p:cNvPr id="8" name="Connettore 1 7">
                <a:extLst>
                  <a:ext uri="{FF2B5EF4-FFF2-40B4-BE49-F238E27FC236}">
                    <a16:creationId xmlns:a16="http://schemas.microsoft.com/office/drawing/2014/main" id="{076AC0C9-481F-7C47-D983-3F487A65F5B6}"/>
                  </a:ext>
                </a:extLst>
              </p:cNvPr>
              <p:cNvCxnSpPr/>
              <p:nvPr/>
            </p:nvCxnSpPr>
            <p:spPr>
              <a:xfrm>
                <a:off x="8905701" y="2061556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nettore 1 8">
                <a:extLst>
                  <a:ext uri="{FF2B5EF4-FFF2-40B4-BE49-F238E27FC236}">
                    <a16:creationId xmlns:a16="http://schemas.microsoft.com/office/drawing/2014/main" id="{1AD3E6D3-136A-7AE3-589E-3C9AF6EC6F7B}"/>
                  </a:ext>
                </a:extLst>
              </p:cNvPr>
              <p:cNvCxnSpPr/>
              <p:nvPr/>
            </p:nvCxnSpPr>
            <p:spPr>
              <a:xfrm>
                <a:off x="8905701" y="2446713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ttore 1 9">
                <a:extLst>
                  <a:ext uri="{FF2B5EF4-FFF2-40B4-BE49-F238E27FC236}">
                    <a16:creationId xmlns:a16="http://schemas.microsoft.com/office/drawing/2014/main" id="{3499D564-DADD-7A42-A3B3-F75FD951AA6A}"/>
                  </a:ext>
                </a:extLst>
              </p:cNvPr>
              <p:cNvCxnSpPr/>
              <p:nvPr/>
            </p:nvCxnSpPr>
            <p:spPr>
              <a:xfrm>
                <a:off x="8905701" y="1834723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ttore 1 10">
                <a:extLst>
                  <a:ext uri="{FF2B5EF4-FFF2-40B4-BE49-F238E27FC236}">
                    <a16:creationId xmlns:a16="http://schemas.microsoft.com/office/drawing/2014/main" id="{AE44C618-E7CD-320C-FE79-D71633709850}"/>
                  </a:ext>
                </a:extLst>
              </p:cNvPr>
              <p:cNvCxnSpPr/>
              <p:nvPr/>
            </p:nvCxnSpPr>
            <p:spPr>
              <a:xfrm>
                <a:off x="8891850" y="3131126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47AE5AAF-D00F-8C91-C51B-995B7B739627}"/>
                  </a:ext>
                </a:extLst>
              </p:cNvPr>
              <p:cNvSpPr txBox="1"/>
              <p:nvPr/>
            </p:nvSpPr>
            <p:spPr>
              <a:xfrm>
                <a:off x="9187038" y="1644066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70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BAE11902-BBDD-B882-738F-EAE2AA422418}"/>
                  </a:ext>
                </a:extLst>
              </p:cNvPr>
              <p:cNvSpPr txBox="1"/>
              <p:nvPr/>
            </p:nvSpPr>
            <p:spPr>
              <a:xfrm>
                <a:off x="9187037" y="1906936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75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49E4249E-83E1-5B8A-A68D-4033C8F0A49C}"/>
                  </a:ext>
                </a:extLst>
              </p:cNvPr>
              <p:cNvSpPr txBox="1"/>
              <p:nvPr/>
            </p:nvSpPr>
            <p:spPr>
              <a:xfrm>
                <a:off x="9209204" y="2298781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EE61B78B-FD1C-90C1-22A1-E9A04409A109}"/>
                  </a:ext>
                </a:extLst>
              </p:cNvPr>
              <p:cNvSpPr txBox="1"/>
              <p:nvPr/>
            </p:nvSpPr>
            <p:spPr>
              <a:xfrm>
                <a:off x="9211978" y="2941672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5</a:t>
                </a:r>
              </a:p>
            </p:txBody>
          </p:sp>
        </p:grpSp>
        <p:sp>
          <p:nvSpPr>
            <p:cNvPr id="17" name="Rettangolo 16">
              <a:extLst>
                <a:ext uri="{FF2B5EF4-FFF2-40B4-BE49-F238E27FC236}">
                  <a16:creationId xmlns:a16="http://schemas.microsoft.com/office/drawing/2014/main" id="{1B1DF19A-D41D-0439-BF3E-A9F218D5D7CE}"/>
                </a:ext>
              </a:extLst>
            </p:cNvPr>
            <p:cNvSpPr/>
            <p:nvPr/>
          </p:nvSpPr>
          <p:spPr>
            <a:xfrm>
              <a:off x="7327756" y="2457559"/>
              <a:ext cx="1157289" cy="352118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811458A-F022-27DF-A80C-1C3FE6CDF063}"/>
              </a:ext>
            </a:extLst>
          </p:cNvPr>
          <p:cNvSpPr txBox="1"/>
          <p:nvPr/>
        </p:nvSpPr>
        <p:spPr>
          <a:xfrm>
            <a:off x="8980194" y="83724"/>
            <a:ext cx="336766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WB </a:t>
            </a:r>
          </a:p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o-IP: FANCJ WT and FANCJ AALA  with full-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enght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Myc-AND-1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B94660D6-A449-BD3F-8642-3E4FB6DDA2FA}"/>
              </a:ext>
            </a:extLst>
          </p:cNvPr>
          <p:cNvSpPr txBox="1"/>
          <p:nvPr/>
        </p:nvSpPr>
        <p:spPr>
          <a:xfrm>
            <a:off x="1458715" y="5286148"/>
            <a:ext cx="32738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1. Input AND-1 </a:t>
            </a:r>
          </a:p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2. Input AND-1</a:t>
            </a:r>
          </a:p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3. IP-anti-Myc (AND-1 with FANCJ WT)</a:t>
            </a:r>
          </a:p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4. IP-anti-Myc (AND-1 with FANCJ AALA)</a:t>
            </a:r>
          </a:p>
        </p:txBody>
      </p:sp>
      <p:grpSp>
        <p:nvGrpSpPr>
          <p:cNvPr id="33" name="Gruppo 32">
            <a:extLst>
              <a:ext uri="{FF2B5EF4-FFF2-40B4-BE49-F238E27FC236}">
                <a16:creationId xmlns:a16="http://schemas.microsoft.com/office/drawing/2014/main" id="{A91EA6F9-DA3F-DD7F-890D-A3EE226ECB74}"/>
              </a:ext>
            </a:extLst>
          </p:cNvPr>
          <p:cNvGrpSpPr/>
          <p:nvPr/>
        </p:nvGrpSpPr>
        <p:grpSpPr>
          <a:xfrm>
            <a:off x="30412" y="1009345"/>
            <a:ext cx="5088921" cy="3932366"/>
            <a:chOff x="142355" y="612652"/>
            <a:chExt cx="5088921" cy="3932366"/>
          </a:xfrm>
        </p:grpSpPr>
        <p:pic>
          <p:nvPicPr>
            <p:cNvPr id="2" name="Immagine 1" descr="Immagine che contiene bianco, nero, schizzo, bianco e nero&#10;&#10;Descrizione generata automaticamente">
              <a:extLst>
                <a:ext uri="{FF2B5EF4-FFF2-40B4-BE49-F238E27FC236}">
                  <a16:creationId xmlns:a16="http://schemas.microsoft.com/office/drawing/2014/main" id="{53716EB6-5A23-9BB9-16B3-F9288A2AB6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9000" contrast="22000"/>
                      </a14:imgEffect>
                    </a14:imgLayer>
                  </a14:imgProps>
                </a:ext>
              </a:extLst>
            </a:blip>
            <a:srcRect l="48207" r="28743" b="24108"/>
            <a:stretch/>
          </p:blipFill>
          <p:spPr>
            <a:xfrm flipH="1">
              <a:off x="1458715" y="612652"/>
              <a:ext cx="2563020" cy="3932366"/>
            </a:xfrm>
            <a:prstGeom prst="rect">
              <a:avLst/>
            </a:prstGeom>
          </p:spPr>
        </p:pic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D980E0BE-28FD-C50A-77A3-FA89FB175AE7}"/>
                </a:ext>
              </a:extLst>
            </p:cNvPr>
            <p:cNvSpPr txBox="1"/>
            <p:nvPr/>
          </p:nvSpPr>
          <p:spPr>
            <a:xfrm>
              <a:off x="1496498" y="1811281"/>
              <a:ext cx="2676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4         3        2       1</a:t>
              </a:r>
            </a:p>
          </p:txBody>
        </p:sp>
        <p:sp>
          <p:nvSpPr>
            <p:cNvPr id="20" name="Rettangolo 19">
              <a:extLst>
                <a:ext uri="{FF2B5EF4-FFF2-40B4-BE49-F238E27FC236}">
                  <a16:creationId xmlns:a16="http://schemas.microsoft.com/office/drawing/2014/main" id="{AFBF2B42-9653-5CD7-9154-A08D4BFCAA28}"/>
                </a:ext>
              </a:extLst>
            </p:cNvPr>
            <p:cNvSpPr/>
            <p:nvPr/>
          </p:nvSpPr>
          <p:spPr>
            <a:xfrm>
              <a:off x="1772600" y="2290145"/>
              <a:ext cx="943092" cy="44007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374D77B0-CDE6-A1FF-2690-0725BCB1AD24}"/>
                </a:ext>
              </a:extLst>
            </p:cNvPr>
            <p:cNvSpPr txBox="1"/>
            <p:nvPr/>
          </p:nvSpPr>
          <p:spPr>
            <a:xfrm>
              <a:off x="142355" y="2247980"/>
              <a:ext cx="15808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Myc (AND-1)</a:t>
              </a:r>
            </a:p>
          </p:txBody>
        </p:sp>
        <p:grpSp>
          <p:nvGrpSpPr>
            <p:cNvPr id="22" name="Gruppo 21">
              <a:extLst>
                <a:ext uri="{FF2B5EF4-FFF2-40B4-BE49-F238E27FC236}">
                  <a16:creationId xmlns:a16="http://schemas.microsoft.com/office/drawing/2014/main" id="{5B443F78-A2D4-5DBC-EF32-5D103A36EE19}"/>
                </a:ext>
              </a:extLst>
            </p:cNvPr>
            <p:cNvGrpSpPr/>
            <p:nvPr/>
          </p:nvGrpSpPr>
          <p:grpSpPr>
            <a:xfrm>
              <a:off x="4007885" y="1652363"/>
              <a:ext cx="1194265" cy="1591538"/>
              <a:chOff x="8891850" y="1654646"/>
              <a:chExt cx="1194265" cy="1591538"/>
            </a:xfrm>
          </p:grpSpPr>
          <p:cxnSp>
            <p:nvCxnSpPr>
              <p:cNvPr id="23" name="Connettore 1 22">
                <a:extLst>
                  <a:ext uri="{FF2B5EF4-FFF2-40B4-BE49-F238E27FC236}">
                    <a16:creationId xmlns:a16="http://schemas.microsoft.com/office/drawing/2014/main" id="{8C16F464-BF2D-41F5-0CA6-E7C1757381D5}"/>
                  </a:ext>
                </a:extLst>
              </p:cNvPr>
              <p:cNvCxnSpPr/>
              <p:nvPr/>
            </p:nvCxnSpPr>
            <p:spPr>
              <a:xfrm>
                <a:off x="8905701" y="2061556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ttore 1 23">
                <a:extLst>
                  <a:ext uri="{FF2B5EF4-FFF2-40B4-BE49-F238E27FC236}">
                    <a16:creationId xmlns:a16="http://schemas.microsoft.com/office/drawing/2014/main" id="{2AF91AA1-5355-BE31-EE5A-9D34054E9429}"/>
                  </a:ext>
                </a:extLst>
              </p:cNvPr>
              <p:cNvCxnSpPr/>
              <p:nvPr/>
            </p:nvCxnSpPr>
            <p:spPr>
              <a:xfrm>
                <a:off x="8905701" y="2446713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ttore 1 24">
                <a:extLst>
                  <a:ext uri="{FF2B5EF4-FFF2-40B4-BE49-F238E27FC236}">
                    <a16:creationId xmlns:a16="http://schemas.microsoft.com/office/drawing/2014/main" id="{F28481A7-A6D9-48C3-E2D2-38F00664BDD4}"/>
                  </a:ext>
                </a:extLst>
              </p:cNvPr>
              <p:cNvCxnSpPr/>
              <p:nvPr/>
            </p:nvCxnSpPr>
            <p:spPr>
              <a:xfrm>
                <a:off x="8905701" y="1834723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ttore 1 25">
                <a:extLst>
                  <a:ext uri="{FF2B5EF4-FFF2-40B4-BE49-F238E27FC236}">
                    <a16:creationId xmlns:a16="http://schemas.microsoft.com/office/drawing/2014/main" id="{527721E4-1EF6-9BC5-D08B-F9E37FF2A725}"/>
                  </a:ext>
                </a:extLst>
              </p:cNvPr>
              <p:cNvCxnSpPr/>
              <p:nvPr/>
            </p:nvCxnSpPr>
            <p:spPr>
              <a:xfrm>
                <a:off x="8891850" y="3131126"/>
                <a:ext cx="3380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A5CF9CCD-2771-ABF4-D33C-4869DF5D14EC}"/>
                  </a:ext>
                </a:extLst>
              </p:cNvPr>
              <p:cNvSpPr txBox="1"/>
              <p:nvPr/>
            </p:nvSpPr>
            <p:spPr>
              <a:xfrm>
                <a:off x="9229902" y="1654646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70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FE2711A5-6259-55BB-242E-F04F047E0F7C}"/>
                  </a:ext>
                </a:extLst>
              </p:cNvPr>
              <p:cNvSpPr txBox="1"/>
              <p:nvPr/>
            </p:nvSpPr>
            <p:spPr>
              <a:xfrm>
                <a:off x="9229901" y="1940339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75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CE6C869F-DF7D-A019-CDE6-B67CD95CFA02}"/>
                  </a:ext>
                </a:extLst>
              </p:cNvPr>
              <p:cNvSpPr txBox="1"/>
              <p:nvPr/>
            </p:nvSpPr>
            <p:spPr>
              <a:xfrm>
                <a:off x="9252068" y="2292428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E24C6EEB-CD9D-6F14-D56C-84C9793884E2}"/>
                  </a:ext>
                </a:extLst>
              </p:cNvPr>
              <p:cNvSpPr txBox="1"/>
              <p:nvPr/>
            </p:nvSpPr>
            <p:spPr>
              <a:xfrm>
                <a:off x="9254842" y="2969185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5</a:t>
                </a:r>
              </a:p>
            </p:txBody>
          </p:sp>
        </p:grpSp>
        <p:cxnSp>
          <p:nvCxnSpPr>
            <p:cNvPr id="31" name="Connettore 1 30">
              <a:extLst>
                <a:ext uri="{FF2B5EF4-FFF2-40B4-BE49-F238E27FC236}">
                  <a16:creationId xmlns:a16="http://schemas.microsoft.com/office/drawing/2014/main" id="{2E7BA302-D6CB-BD05-D36D-661EFC2D5786}"/>
                </a:ext>
              </a:extLst>
            </p:cNvPr>
            <p:cNvCxnSpPr/>
            <p:nvPr/>
          </p:nvCxnSpPr>
          <p:spPr>
            <a:xfrm>
              <a:off x="4004170" y="3704987"/>
              <a:ext cx="3380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070B6691-FBC1-54AD-709F-9429C5F1264B}"/>
                </a:ext>
              </a:extLst>
            </p:cNvPr>
            <p:cNvSpPr txBox="1"/>
            <p:nvPr/>
          </p:nvSpPr>
          <p:spPr>
            <a:xfrm>
              <a:off x="4400003" y="3531885"/>
              <a:ext cx="831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523846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Words>93</Words>
  <Application>Microsoft Macintosh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A MARIA PISANI</dc:creator>
  <cp:lastModifiedBy>FRANCESCA MARIA PISANI</cp:lastModifiedBy>
  <cp:revision>2</cp:revision>
  <dcterms:created xsi:type="dcterms:W3CDTF">2023-11-30T11:26:38Z</dcterms:created>
  <dcterms:modified xsi:type="dcterms:W3CDTF">2023-12-02T15:39:33Z</dcterms:modified>
</cp:coreProperties>
</file>